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3E472A-B3C0-4224-86A7-29C3ABBD9F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45627DC-7666-4636-85D5-08F360096E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D195B27-5E7E-44EC-AA52-7A33009901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5DC418-33CC-4AA4-A9DD-41CBBFAD19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683300-184C-4DED-8CD2-98E89AAFDC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4326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79EB3B-68A9-49E6-ADB7-618BE675EF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7AF2EA-CB70-46F8-8180-C54A276004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CD3157-B481-4A55-9740-1B92DA8588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36E387-CE87-4EFC-B008-E3369C1247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44B7FF-C772-44E2-9802-263C138D7A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819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0920082-B41D-4FC6-9548-9E242C3FBEF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ACBAAD5-CD49-4E23-9B10-64BF373B279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094CE5-6FB1-4309-8F70-9D221F285F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752CE6-4CFA-4D7C-860A-F7F3962C77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80C23F-A795-4C47-AC01-245FCF2EC5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8397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23A1093-072B-4EEA-9640-5B1F115769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75EB5A1-8F3B-41D2-B189-046084B9AC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71B9A4E-3F46-4EB7-822D-796D0E0E05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0223D7-7029-4393-81D8-CFC043C481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1589A2-0D20-4163-847E-180E6881F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9244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A4E9A6-9A6E-41E7-8164-DBDA32B12F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41A387F-97F2-4228-9ABA-533499F4A7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FE88A9-A1A1-4EF8-BD69-AA8F566FBC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76BEAB-0D6F-40BF-BC0A-98B8ED2BAB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F70512D-A82A-4977-9061-C7DA82E63A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0026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ADC41BD-885E-4376-A169-805E3E1112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51F325-E649-4EB9-B01D-11933F7B102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58750D5-B131-4AB8-A5EC-DC71A2B5742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E0FBDB-D9A9-412F-A9ED-AE40D66F6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E8E16EC-718C-4DFD-9D51-FCBE948E5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F7B1357-9EAD-46BA-9D84-6F3E0BC4C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8732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772B49-E736-4678-B959-50218903590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B6A021-7BA4-440A-AFBE-47DA64695D2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67FF70C-ECA4-403A-930A-0A3D7802150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3FFD4D8-1621-47DB-907D-3D880A4C68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DEA1EDD-0E69-4189-87B2-7E7CB561EA2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8CE46D2-F824-4EFC-AA93-916C973F31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E1AD4AB-4CCA-4F5F-9109-275873D27C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1B3DDD0-75B5-4492-B65B-1AA5D35B70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073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3840C2-87C6-40BA-8BA3-1EB87C802D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4AAF644-357C-4218-BF45-7BAF482735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3D1D5E-FA59-49E6-8C16-626621000D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204D621-75C4-4AC0-9BCE-35B4B5190C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35753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F1B0A22-6B0F-4148-8805-080949CB30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AB225F8-532F-411C-AC9D-A28E4C692B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3E0547B-AA45-4F8F-BD8A-51E604FB05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65070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42A486-944A-4F7F-BFEF-1A70079D38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B0DACC-FE9F-4955-A849-D47718B1A9B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6CA6111-9ABE-4C92-A325-A879230C7C7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B5AF73-7770-4FF7-99B6-9BB1C3C184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E2E6B19-E685-4612-A1FD-67D54DAC4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39B5F8-12D3-451D-83AB-AFD66FC7B8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6680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44F59D-98C7-44C7-8F41-50F5B7A66F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330D65F-556B-47EB-89F1-34BA17D7E6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A67976-2F8F-48F1-9E68-71CCAEC829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FB78AF-9B85-4971-AACB-93235FC5F0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DE4860-183D-4AA0-A962-7C746BE93C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4D596CE-F92C-4C8B-BBAD-1D8BA1CBF8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0422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28CF9AF-1CDE-4C8D-B723-CC1F9263CB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291945-9D21-487F-93C1-E7A73B7995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636D4D0-1B9D-442E-80E6-EC53DAFD77B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0A455F-04B3-4678-AD4C-DC9CE46C54BC}" type="datetimeFigureOut">
              <a:rPr lang="en-US" smtClean="0"/>
              <a:t>1/28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BE9E91-81C6-4CCB-9150-152A7F97645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456E19-3812-4873-A01C-1E7BB5DF278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EB7D22-F6A3-46F8-B270-F3BF60D6CDF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1055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5417185"/>
              </p:ext>
            </p:extLst>
          </p:nvPr>
        </p:nvGraphicFramePr>
        <p:xfrm>
          <a:off x="3551069" y="310720"/>
          <a:ext cx="4580877" cy="5724953"/>
        </p:xfrm>
        <a:graphic>
          <a:graphicData uri="http://schemas.openxmlformats.org/drawingml/2006/table">
            <a:tbl>
              <a:tblPr firstRow="1" bandRow="1">
                <a:tableStyleId>{0660B408-B3CF-4A94-85FC-2B1E0A45F4A2}</a:tableStyleId>
              </a:tblPr>
              <a:tblGrid>
                <a:gridCol w="28941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68675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84830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Query</a:t>
                      </a:r>
                      <a:r>
                        <a:rPr lang="en-US" sz="2000" b="1" baseline="0" dirty="0">
                          <a:latin typeface="Arial" pitchFamily="34" charset="0"/>
                          <a:cs typeface="Arial" pitchFamily="34" charset="0"/>
                        </a:rPr>
                        <a:t> term</a:t>
                      </a:r>
                      <a:endParaRPr lang="en-US" sz="2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# genes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09170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Bariatric surgery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34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BMI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348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50426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Body mass index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455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Fat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840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Fat mas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278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FFM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4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25781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Fat free mas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145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Lean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130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415305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Leanness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1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Obese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476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59593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Obesity</a:t>
                      </a: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1692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625781">
                <a:tc>
                  <a:txBody>
                    <a:bodyPr/>
                    <a:lstStyle/>
                    <a:p>
                      <a:r>
                        <a:rPr lang="en-US" sz="2000" b="1" dirty="0">
                          <a:latin typeface="Arial" pitchFamily="34" charset="0"/>
                          <a:cs typeface="Arial" pitchFamily="34" charset="0"/>
                        </a:rPr>
                        <a:t>Overweight</a:t>
                      </a:r>
                      <a:r>
                        <a:rPr lang="en-US" sz="2000" b="1" baseline="0" dirty="0">
                          <a:latin typeface="Arial" pitchFamily="34" charset="0"/>
                          <a:cs typeface="Arial" pitchFamily="34" charset="0"/>
                        </a:rPr>
                        <a:t> </a:t>
                      </a:r>
                      <a:endParaRPr lang="en-US" sz="2000" b="1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dirty="0">
                          <a:latin typeface="Arial" pitchFamily="34" charset="0"/>
                          <a:cs typeface="Arial" pitchFamily="34" charset="0"/>
                        </a:rPr>
                        <a:t>195</a:t>
                      </a:r>
                    </a:p>
                  </a:txBody>
                  <a:tcPr marL="68580" marR="68580" marT="34290" marB="34290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4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harm User</dc:creator>
  <cp:lastModifiedBy>Pharm User</cp:lastModifiedBy>
  <cp:revision>1</cp:revision>
  <dcterms:created xsi:type="dcterms:W3CDTF">2019-01-28T18:10:11Z</dcterms:created>
  <dcterms:modified xsi:type="dcterms:W3CDTF">2019-01-28T18:11:37Z</dcterms:modified>
</cp:coreProperties>
</file>